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.D. Moerland" initials="PM" lastIdx="6" clrIdx="0"/>
  <p:cmAuthor id="2" name="Maryam Soleimani Dodaran" initials="" lastIdx="2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2BCE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74"/>
  </p:normalViewPr>
  <p:slideViewPr>
    <p:cSldViewPr snapToGrid="0" snapToObjects="1">
      <p:cViewPr varScale="1">
        <p:scale>
          <a:sx n="71" d="100"/>
          <a:sy n="71" d="100"/>
        </p:scale>
        <p:origin x="2508" y="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68E6E9F-4FB3-9747-AD5B-A0B5D1810418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606800" y="514350"/>
            <a:ext cx="1930400" cy="2571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14400" y="3257550"/>
            <a:ext cx="7315200" cy="30861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29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01E4BF-B8E0-D74A-9D2D-2D3F6444625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8661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42433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6393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39009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28614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87635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1404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212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604714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861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85985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32765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2BE162-40B1-C143-AF01-25F08632A65B}" type="datetimeFigureOut">
              <a:rPr lang="en-US" smtClean="0"/>
              <a:t>4/2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2A1436-5BF0-A440-9DA3-82447F7957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5361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12192"/>
            <a:ext cx="199605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NL" b="1" dirty="0"/>
              <a:t>ADDITIONAL FILE 6</a:t>
            </a:r>
          </a:p>
        </p:txBody>
      </p:sp>
      <p:grpSp>
        <p:nvGrpSpPr>
          <p:cNvPr id="3" name="Group 2"/>
          <p:cNvGrpSpPr/>
          <p:nvPr/>
        </p:nvGrpSpPr>
        <p:grpSpPr>
          <a:xfrm>
            <a:off x="145378" y="797165"/>
            <a:ext cx="3148140" cy="3359302"/>
            <a:chOff x="328255" y="797165"/>
            <a:chExt cx="3148140" cy="3359302"/>
          </a:xfrm>
        </p:grpSpPr>
        <p:sp>
          <p:nvSpPr>
            <p:cNvPr id="4" name="Oval 3"/>
            <p:cNvSpPr>
              <a:spLocks noChangeAspect="1"/>
            </p:cNvSpPr>
            <p:nvPr/>
          </p:nvSpPr>
          <p:spPr>
            <a:xfrm>
              <a:off x="691662" y="1137136"/>
              <a:ext cx="1800000" cy="180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" name="Oval 4"/>
            <p:cNvSpPr>
              <a:spLocks noChangeAspect="1"/>
            </p:cNvSpPr>
            <p:nvPr/>
          </p:nvSpPr>
          <p:spPr>
            <a:xfrm>
              <a:off x="1676395" y="1137137"/>
              <a:ext cx="1800000" cy="180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" name="Oval 5"/>
            <p:cNvSpPr>
              <a:spLocks noChangeAspect="1"/>
            </p:cNvSpPr>
            <p:nvPr/>
          </p:nvSpPr>
          <p:spPr>
            <a:xfrm>
              <a:off x="1184029" y="1934302"/>
              <a:ext cx="1800000" cy="1800000"/>
            </a:xfrm>
            <a:prstGeom prst="ellipse">
              <a:avLst/>
            </a:prstGeom>
            <a:noFill/>
            <a:ln>
              <a:solidFill>
                <a:schemeClr val="tx1"/>
              </a:solidFill>
            </a:ln>
            <a:effectLst/>
          </p:spPr>
          <p:style>
            <a:lnRef idx="1">
              <a:schemeClr val="dk1"/>
            </a:lnRef>
            <a:fillRef idx="3">
              <a:schemeClr val="dk1"/>
            </a:fillRef>
            <a:effectRef idx="2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822324" y="3787135"/>
              <a:ext cx="60907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/>
                <a:t>TAM</a:t>
              </a:r>
              <a:endParaRPr lang="en-GB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328255" y="797165"/>
              <a:ext cx="11961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/>
                <a:t>ER+/HER2-</a:t>
              </a:r>
              <a:endParaRPr lang="en-GB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2872161" y="808889"/>
              <a:ext cx="37542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l-NL" dirty="0"/>
                <a:t>AI</a:t>
              </a:r>
              <a:endParaRPr lang="en-GB" dirty="0"/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1934308" y="2133457"/>
              <a:ext cx="4025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/>
                <a:t>0</a:t>
              </a:r>
              <a:endParaRPr lang="en-GB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1910863" y="1512137"/>
              <a:ext cx="43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/>
                <a:t>0</a:t>
              </a:r>
              <a:endParaRPr lang="en-GB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1910864" y="3000968"/>
              <a:ext cx="4320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/>
                <a:t>2</a:t>
              </a:r>
              <a:endParaRPr lang="en-GB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371603" y="2379641"/>
              <a:ext cx="4025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/>
                <a:t>3</a:t>
              </a:r>
              <a:endParaRPr lang="en-GB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125423" y="1523861"/>
              <a:ext cx="540000" cy="370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 smtClean="0"/>
                <a:t>131</a:t>
              </a:r>
              <a:endParaRPr lang="en-GB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602533" y="1523862"/>
              <a:ext cx="540000" cy="3708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/>
                <a:t>1</a:t>
              </a:r>
              <a:endParaRPr lang="en-GB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450124" y="2379642"/>
              <a:ext cx="40252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l-NL" dirty="0"/>
                <a:t>0</a:t>
              </a:r>
              <a:endParaRPr lang="en-GB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328773" y="7965025"/>
            <a:ext cx="6214267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b="1" dirty="0"/>
              <a:t>Additional File 6. </a:t>
            </a:r>
            <a:r>
              <a:rPr lang="en-GB" sz="1600" dirty="0"/>
              <a:t>Venn diagram of single-locus signatures in the ER+/HER2-, TAM and AI cohorts. </a:t>
            </a:r>
          </a:p>
        </p:txBody>
      </p:sp>
    </p:spTree>
    <p:extLst>
      <p:ext uri="{BB962C8B-B14F-4D97-AF65-F5344CB8AC3E}">
        <p14:creationId xmlns:p14="http://schemas.microsoft.com/office/powerpoint/2010/main" val="105833861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08</TotalTime>
  <Words>35</Words>
  <Application>Microsoft Office PowerPoint</Application>
  <PresentationFormat>On-screen Show 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UV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yam Soleimani Dodaran</dc:creator>
  <cp:lastModifiedBy>P.D. Moerland</cp:lastModifiedBy>
  <cp:revision>187</cp:revision>
  <dcterms:created xsi:type="dcterms:W3CDTF">2018-08-27T08:57:01Z</dcterms:created>
  <dcterms:modified xsi:type="dcterms:W3CDTF">2020-04-22T17:47:40Z</dcterms:modified>
</cp:coreProperties>
</file>